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  <p:sldId id="261" r:id="rId3"/>
  </p:sldIdLst>
  <p:sldSz cx="6858000" cy="9144000" type="letter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orley Holbrook" initials="CH" lastIdx="1" clrIdx="0">
    <p:extLst>
      <p:ext uri="{19B8F6BF-5375-455C-9EA6-DF929625EA0E}">
        <p15:presenceInfo xmlns:p15="http://schemas.microsoft.com/office/powerpoint/2012/main" userId="S-1-5-21-447180386-889211592-312552118-119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 showGuides="1">
      <p:cViewPr varScale="1">
        <p:scale>
          <a:sx n="85" d="100"/>
          <a:sy n="85" d="100"/>
        </p:scale>
        <p:origin x="2244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581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067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287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870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288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12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5351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791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737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246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027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F4DA3F-5B8B-4FF8-BDC2-B70EA092D364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F61437-ADC4-4890-A07E-4BD5454D8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259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4470"/>
            <a:ext cx="6858000" cy="88750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42072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4834" y="8025192"/>
            <a:ext cx="69234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Linkage map of Florida-07 x GP-NC WS 16 RIL population.  SSR markers are colored in purple.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hFAD2B_hybprobe marker is colored in blue.  Only non-redundant loci were used for map illustrat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905" b="12517"/>
          <a:stretch/>
        </p:blipFill>
        <p:spPr>
          <a:xfrm>
            <a:off x="0" y="134471"/>
            <a:ext cx="6453051" cy="77642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5427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0</TotalTime>
  <Words>38</Words>
  <Application>Microsoft Office PowerPoint</Application>
  <PresentationFormat>Letter Paper (8.5x11 in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t Chu</dc:creator>
  <cp:lastModifiedBy>Juliet Chu</cp:lastModifiedBy>
  <cp:revision>90</cp:revision>
  <cp:lastPrinted>2018-03-19T14:08:51Z</cp:lastPrinted>
  <dcterms:created xsi:type="dcterms:W3CDTF">2018-02-01T16:01:37Z</dcterms:created>
  <dcterms:modified xsi:type="dcterms:W3CDTF">2018-07-25T20:19:09Z</dcterms:modified>
</cp:coreProperties>
</file>